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8973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7476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2471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0773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257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745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97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1412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7898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6228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8317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68C83-AED0-4C68-8406-F8E3C01A2AC7}" type="datetimeFigureOut">
              <a:rPr lang="zh-CN" altLang="en-US" smtClean="0"/>
              <a:t>2019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7AB044-C851-4B62-B077-CC6F744647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5673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301579" y="6133199"/>
            <a:ext cx="98049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nnotation of putative motifs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ER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s identified by MEME. 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2928" y="768096"/>
            <a:ext cx="6486144" cy="5321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1440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P R 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Windows User</cp:lastModifiedBy>
  <cp:revision>2</cp:revision>
  <dcterms:created xsi:type="dcterms:W3CDTF">2019-02-22T04:11:42Z</dcterms:created>
  <dcterms:modified xsi:type="dcterms:W3CDTF">2019-02-22T04:16:30Z</dcterms:modified>
</cp:coreProperties>
</file>